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snapVertSplitter="1" vertBarState="minimized" horz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968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66800" y="304801"/>
            <a:ext cx="7239000" cy="571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500034" y="6215082"/>
            <a:ext cx="8286808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IN" sz="1100" b="1" dirty="0" smtClean="0">
                <a:latin typeface="Times New Roman" pitchFamily="18" charset="0"/>
                <a:cs typeface="Times New Roman" pitchFamily="18" charset="0"/>
              </a:rPr>
              <a:t>Figure S1 </a:t>
            </a:r>
            <a:r>
              <a:rPr lang="en-IN" sz="1100" dirty="0" err="1" smtClean="0">
                <a:latin typeface="Times New Roman" pitchFamily="18" charset="0"/>
                <a:cs typeface="Times New Roman" pitchFamily="18" charset="0"/>
              </a:rPr>
              <a:t>Phylogenetic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 tree of PRPs of 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Sorghum, </a:t>
            </a:r>
            <a:r>
              <a:rPr lang="en-IN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IN" sz="1100" i="1" dirty="0" smtClean="0">
                <a:latin typeface="Times New Roman" pitchFamily="18" charset="0"/>
                <a:cs typeface="Times New Roman" pitchFamily="18" charset="0"/>
              </a:rPr>
              <a:t> Arabidopsis</a:t>
            </a:r>
            <a:r>
              <a:rPr lang="en-IN" sz="11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IN" sz="1100" b="1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Sb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Sorghum bicolor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; Os, </a:t>
            </a:r>
            <a:r>
              <a:rPr lang="en-US" sz="1100" i="1" dirty="0" err="1" smtClean="0">
                <a:latin typeface="Times New Roman" pitchFamily="18" charset="0"/>
                <a:cs typeface="Times New Roman" pitchFamily="18" charset="0"/>
              </a:rPr>
              <a:t>Oryza</a:t>
            </a:r>
            <a:r>
              <a:rPr lang="en-US" sz="1100" i="1" dirty="0" smtClean="0">
                <a:latin typeface="Times New Roman" pitchFamily="18" charset="0"/>
                <a:cs typeface="Times New Roman" pitchFamily="18" charset="0"/>
              </a:rPr>
              <a:t> sativa;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PRP,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Proline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-rich proteins.</a:t>
            </a:r>
            <a:endParaRPr lang="en-IN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29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GARAJ</dc:creator>
  <cp:lastModifiedBy>NAGARAJU</cp:lastModifiedBy>
  <cp:revision>39</cp:revision>
  <dcterms:created xsi:type="dcterms:W3CDTF">2006-08-16T00:00:00Z</dcterms:created>
  <dcterms:modified xsi:type="dcterms:W3CDTF">2022-08-06T06:53:44Z</dcterms:modified>
</cp:coreProperties>
</file>